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05184-730D-4D94-94DB-92863C8B89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1A569-7B1D-4BD3-9168-3163D207F0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648C86-54F7-4B5C-B30A-A4A81B083A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EC977-D732-4EF7-8E0F-9793CB83A7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B4F92-4345-48DD-BB0F-0A5C6D3B99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D5E73-27C6-4521-BA19-94E6EF111A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96EA85-713C-45E3-B2DB-7A11D58935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8840D-4257-40D7-976C-1C4F32F1C0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CAFF6-2174-4B83-80F9-FFE8F74C95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C1EFF-13F0-4733-9EA6-2EF14A9EE6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3FAC7-600D-4B26-90DC-9D017CC65D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BDB2A8-57D5-453A-9AF7-B2BB89FD5F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FB378B-A3E9-4D0E-B38B-01368327AA71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907520" y="1604880"/>
            <a:ext cx="238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α-smooth muscle act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3390840" y="1087560"/>
            <a:ext cx="1463760" cy="13716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3395520" y="4467240"/>
            <a:ext cx="1473480" cy="129384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3"/>
          <a:stretch/>
        </p:blipFill>
        <p:spPr>
          <a:xfrm>
            <a:off x="3400560" y="2755800"/>
            <a:ext cx="1458720" cy="138456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3474720" y="1370160"/>
            <a:ext cx="47340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0 µ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549600" y="1390680"/>
            <a:ext cx="33336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908600" y="3279600"/>
            <a:ext cx="364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smooth muscle myosin heavy cha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907520" y="4946760"/>
            <a:ext cx="3297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non-muscle myosin heavy cha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454560" y="4568760"/>
            <a:ext cx="23796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468600" y="2876400"/>
            <a:ext cx="23832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957760" y="836640"/>
            <a:ext cx="32976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957760" y="2525760"/>
            <a:ext cx="32976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957760" y="4214880"/>
            <a:ext cx="32976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8756280" y="6521400"/>
            <a:ext cx="110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7" dur="5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nodeType="with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10" dur="500"/>
                                        <p:tgtEl>
                                          <p:spTgt spid="4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26T15:00:11Z</dcterms:created>
  <dc:creator>Vero</dc:creator>
  <dc:description/>
  <dc:language>en-US</dc:language>
  <cp:lastModifiedBy>Vero</cp:lastModifiedBy>
  <dcterms:modified xsi:type="dcterms:W3CDTF">2012-09-24T12:11:21Z</dcterms:modified>
  <cp:revision>10</cp:revision>
  <dc:subject/>
  <dc:title>Diapositive 1</dc:title>
</cp:coreProperties>
</file>